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4168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gia%20Papale\Documents\Ligia\Post%20Doc%20Reid\New%20ARRAY%20project\Methylation%20Sites%20and%20Percentages\PRRT%20Methylation%20Sites%20and%20Percentag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gia%20Papale\Documents\Ligia\Post%20Doc%20Reid\New%20ARRAY%20project\Methylation%20Sites%20and%20Percentages\RGMA%20Methylation%20sites%20and%20percentag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gia%20Papale\Documents\Ligia\Post%20Doc%20Reid\New%20ARRAY%20project\Methylation%20Sites%20and%20Percentages\SFRP%20Methylation%20Sites%20and%20Percentag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gia%20Papale\Documents\Ligia\Post%20Doc%20Reid\New%20ARRAY%20project\Methylation%20Sites%20and%20Percentages\HOXD2%20Methylation%20Sites%20and%20Percentage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igia%20Papale\Documents\Ligia\Post%20Doc%20Reid\New%20ARRAY%20project\Methylation%20Sites%20and%20Percentages\Rassf1%20Methylation%20site%20and%20Percentag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Sheet1!$AI$6:$BY$6</c:f>
              <c:strCache>
                <c:ptCount val="43"/>
                <c:pt idx="0">
                  <c:v>Liver</c:v>
                </c:pt>
                <c:pt idx="1">
                  <c:v>Placenta</c:v>
                </c:pt>
                <c:pt idx="2">
                  <c:v>Heart</c:v>
                </c:pt>
                <c:pt idx="4">
                  <c:v>Liver</c:v>
                </c:pt>
                <c:pt idx="5">
                  <c:v>Placenta</c:v>
                </c:pt>
                <c:pt idx="6">
                  <c:v>Heart</c:v>
                </c:pt>
                <c:pt idx="8">
                  <c:v>Liver</c:v>
                </c:pt>
                <c:pt idx="9">
                  <c:v>Placenta</c:v>
                </c:pt>
                <c:pt idx="10">
                  <c:v>Heart</c:v>
                </c:pt>
                <c:pt idx="12">
                  <c:v>Liver</c:v>
                </c:pt>
                <c:pt idx="13">
                  <c:v>Placenta</c:v>
                </c:pt>
                <c:pt idx="14">
                  <c:v>Heart</c:v>
                </c:pt>
                <c:pt idx="16">
                  <c:v>Liver</c:v>
                </c:pt>
                <c:pt idx="17">
                  <c:v>Placenta</c:v>
                </c:pt>
                <c:pt idx="18">
                  <c:v>Heart</c:v>
                </c:pt>
                <c:pt idx="20">
                  <c:v>Liver</c:v>
                </c:pt>
                <c:pt idx="21">
                  <c:v>Placenta</c:v>
                </c:pt>
                <c:pt idx="22">
                  <c:v>Heart</c:v>
                </c:pt>
                <c:pt idx="24">
                  <c:v>Liver</c:v>
                </c:pt>
                <c:pt idx="25">
                  <c:v>Placenta</c:v>
                </c:pt>
                <c:pt idx="26">
                  <c:v>Heart</c:v>
                </c:pt>
                <c:pt idx="28">
                  <c:v>Liver</c:v>
                </c:pt>
                <c:pt idx="29">
                  <c:v>Placenta</c:v>
                </c:pt>
                <c:pt idx="30">
                  <c:v>Heart</c:v>
                </c:pt>
                <c:pt idx="32">
                  <c:v>Liver</c:v>
                </c:pt>
                <c:pt idx="33">
                  <c:v>Placenta</c:v>
                </c:pt>
                <c:pt idx="34">
                  <c:v>Heart</c:v>
                </c:pt>
                <c:pt idx="36">
                  <c:v>Liver</c:v>
                </c:pt>
                <c:pt idx="37">
                  <c:v>Placenta</c:v>
                </c:pt>
                <c:pt idx="38">
                  <c:v>Heart</c:v>
                </c:pt>
                <c:pt idx="40">
                  <c:v>Liver</c:v>
                </c:pt>
                <c:pt idx="41">
                  <c:v>Placenta</c:v>
                </c:pt>
                <c:pt idx="42">
                  <c:v>Heart</c:v>
                </c:pt>
              </c:strCache>
            </c:strRef>
          </c:cat>
          <c:val>
            <c:numRef>
              <c:f>Sheet1!$AI$7:$BY$7</c:f>
              <c:numCache>
                <c:formatCode>General</c:formatCode>
                <c:ptCount val="43"/>
                <c:pt idx="0">
                  <c:v>4.545454545454546</c:v>
                </c:pt>
                <c:pt idx="1">
                  <c:v>65.3846153846154</c:v>
                </c:pt>
                <c:pt idx="2">
                  <c:v>15.38461538461538</c:v>
                </c:pt>
                <c:pt idx="4">
                  <c:v>18.1818181818182</c:v>
                </c:pt>
                <c:pt idx="5">
                  <c:v>69.23076923076921</c:v>
                </c:pt>
                <c:pt idx="6">
                  <c:v>3.846153846153844</c:v>
                </c:pt>
                <c:pt idx="8">
                  <c:v>0.0</c:v>
                </c:pt>
                <c:pt idx="9">
                  <c:v>73.07692307692305</c:v>
                </c:pt>
                <c:pt idx="10">
                  <c:v>23.07692307692307</c:v>
                </c:pt>
                <c:pt idx="12">
                  <c:v>4.545454545454546</c:v>
                </c:pt>
                <c:pt idx="13">
                  <c:v>76.92307692307686</c:v>
                </c:pt>
                <c:pt idx="14">
                  <c:v>23.07692307692307</c:v>
                </c:pt>
                <c:pt idx="16">
                  <c:v>4.545454545454546</c:v>
                </c:pt>
                <c:pt idx="17">
                  <c:v>61.53846153846154</c:v>
                </c:pt>
                <c:pt idx="18">
                  <c:v>0.0</c:v>
                </c:pt>
                <c:pt idx="20">
                  <c:v>9.0909090909091</c:v>
                </c:pt>
                <c:pt idx="21">
                  <c:v>76.92307692307686</c:v>
                </c:pt>
                <c:pt idx="22">
                  <c:v>30.76923076923077</c:v>
                </c:pt>
                <c:pt idx="24">
                  <c:v>9.0909090909091</c:v>
                </c:pt>
                <c:pt idx="25">
                  <c:v>88.46153846153846</c:v>
                </c:pt>
                <c:pt idx="26">
                  <c:v>0.0</c:v>
                </c:pt>
                <c:pt idx="28">
                  <c:v>4.545454545454546</c:v>
                </c:pt>
                <c:pt idx="29">
                  <c:v>65.3846153846154</c:v>
                </c:pt>
                <c:pt idx="30">
                  <c:v>0.0</c:v>
                </c:pt>
                <c:pt idx="32">
                  <c:v>4.545454545454546</c:v>
                </c:pt>
                <c:pt idx="33">
                  <c:v>73.07692307692305</c:v>
                </c:pt>
                <c:pt idx="34">
                  <c:v>7.692307692307692</c:v>
                </c:pt>
                <c:pt idx="36">
                  <c:v>4.545454545454546</c:v>
                </c:pt>
                <c:pt idx="37">
                  <c:v>69.23076923076921</c:v>
                </c:pt>
                <c:pt idx="38">
                  <c:v>7.692307692307692</c:v>
                </c:pt>
                <c:pt idx="40">
                  <c:v>4.545454545454546</c:v>
                </c:pt>
                <c:pt idx="41">
                  <c:v>76.92307692307686</c:v>
                </c:pt>
                <c:pt idx="42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3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0"/>
            <c:invertIfNegative val="0"/>
            <c:bubble3D val="0"/>
          </c:dPt>
          <c:dPt>
            <c:idx val="41"/>
            <c:invertIfNegative val="0"/>
            <c:bubble3D val="0"/>
          </c:dPt>
          <c:dPt>
            <c:idx val="42"/>
            <c:invertIfNegative val="0"/>
            <c:bubble3D val="0"/>
          </c:dPt>
          <c:cat>
            <c:strRef>
              <c:f>Sheet1!$AI$6:$BY$6</c:f>
              <c:strCache>
                <c:ptCount val="43"/>
                <c:pt idx="0">
                  <c:v>Liver</c:v>
                </c:pt>
                <c:pt idx="1">
                  <c:v>Placenta</c:v>
                </c:pt>
                <c:pt idx="2">
                  <c:v>Heart</c:v>
                </c:pt>
                <c:pt idx="4">
                  <c:v>Liver</c:v>
                </c:pt>
                <c:pt idx="5">
                  <c:v>Placenta</c:v>
                </c:pt>
                <c:pt idx="6">
                  <c:v>Heart</c:v>
                </c:pt>
                <c:pt idx="8">
                  <c:v>Liver</c:v>
                </c:pt>
                <c:pt idx="9">
                  <c:v>Placenta</c:v>
                </c:pt>
                <c:pt idx="10">
                  <c:v>Heart</c:v>
                </c:pt>
                <c:pt idx="12">
                  <c:v>Liver</c:v>
                </c:pt>
                <c:pt idx="13">
                  <c:v>Placenta</c:v>
                </c:pt>
                <c:pt idx="14">
                  <c:v>Heart</c:v>
                </c:pt>
                <c:pt idx="16">
                  <c:v>Liver</c:v>
                </c:pt>
                <c:pt idx="17">
                  <c:v>Placenta</c:v>
                </c:pt>
                <c:pt idx="18">
                  <c:v>Heart</c:v>
                </c:pt>
                <c:pt idx="20">
                  <c:v>Liver</c:v>
                </c:pt>
                <c:pt idx="21">
                  <c:v>Placenta</c:v>
                </c:pt>
                <c:pt idx="22">
                  <c:v>Heart</c:v>
                </c:pt>
                <c:pt idx="24">
                  <c:v>Liver</c:v>
                </c:pt>
                <c:pt idx="25">
                  <c:v>Placenta</c:v>
                </c:pt>
                <c:pt idx="26">
                  <c:v>Heart</c:v>
                </c:pt>
                <c:pt idx="28">
                  <c:v>Liver</c:v>
                </c:pt>
                <c:pt idx="29">
                  <c:v>Placenta</c:v>
                </c:pt>
                <c:pt idx="30">
                  <c:v>Heart</c:v>
                </c:pt>
                <c:pt idx="32">
                  <c:v>Liver</c:v>
                </c:pt>
                <c:pt idx="33">
                  <c:v>Placenta</c:v>
                </c:pt>
                <c:pt idx="34">
                  <c:v>Heart</c:v>
                </c:pt>
                <c:pt idx="36">
                  <c:v>Liver</c:v>
                </c:pt>
                <c:pt idx="37">
                  <c:v>Placenta</c:v>
                </c:pt>
                <c:pt idx="38">
                  <c:v>Heart</c:v>
                </c:pt>
                <c:pt idx="40">
                  <c:v>Liver</c:v>
                </c:pt>
                <c:pt idx="41">
                  <c:v>Placenta</c:v>
                </c:pt>
                <c:pt idx="42">
                  <c:v>Heart</c:v>
                </c:pt>
              </c:strCache>
            </c:strRef>
          </c:cat>
          <c:val>
            <c:numRef>
              <c:f>Sheet1!$AI$8:$BY$8</c:f>
              <c:numCache>
                <c:formatCode>General</c:formatCode>
                <c:ptCount val="43"/>
                <c:pt idx="0">
                  <c:v>14.7</c:v>
                </c:pt>
                <c:pt idx="1">
                  <c:v>52.3</c:v>
                </c:pt>
                <c:pt idx="2">
                  <c:v>15.7</c:v>
                </c:pt>
                <c:pt idx="4">
                  <c:v>0.5</c:v>
                </c:pt>
                <c:pt idx="5">
                  <c:v>57.2</c:v>
                </c:pt>
                <c:pt idx="6">
                  <c:v>0.4</c:v>
                </c:pt>
                <c:pt idx="8">
                  <c:v>15.1</c:v>
                </c:pt>
                <c:pt idx="9">
                  <c:v>76.3</c:v>
                </c:pt>
                <c:pt idx="10">
                  <c:v>14.9</c:v>
                </c:pt>
                <c:pt idx="12">
                  <c:v>17.6</c:v>
                </c:pt>
                <c:pt idx="13">
                  <c:v>78.3</c:v>
                </c:pt>
                <c:pt idx="14">
                  <c:v>15.9</c:v>
                </c:pt>
                <c:pt idx="16">
                  <c:v>11.8</c:v>
                </c:pt>
                <c:pt idx="17">
                  <c:v>73.3</c:v>
                </c:pt>
                <c:pt idx="18">
                  <c:v>10.6</c:v>
                </c:pt>
                <c:pt idx="20">
                  <c:v>20.6</c:v>
                </c:pt>
                <c:pt idx="21">
                  <c:v>81.6</c:v>
                </c:pt>
                <c:pt idx="22">
                  <c:v>29.3</c:v>
                </c:pt>
                <c:pt idx="24">
                  <c:v>10.4</c:v>
                </c:pt>
                <c:pt idx="25">
                  <c:v>65.4</c:v>
                </c:pt>
                <c:pt idx="26">
                  <c:v>10.6</c:v>
                </c:pt>
                <c:pt idx="28">
                  <c:v>9.200000000000001</c:v>
                </c:pt>
                <c:pt idx="29">
                  <c:v>77.7</c:v>
                </c:pt>
                <c:pt idx="30">
                  <c:v>11.7</c:v>
                </c:pt>
                <c:pt idx="32">
                  <c:v>3.6</c:v>
                </c:pt>
                <c:pt idx="33">
                  <c:v>62.0</c:v>
                </c:pt>
                <c:pt idx="34">
                  <c:v>3.1</c:v>
                </c:pt>
                <c:pt idx="36">
                  <c:v>7.0</c:v>
                </c:pt>
                <c:pt idx="37">
                  <c:v>59.2</c:v>
                </c:pt>
                <c:pt idx="38">
                  <c:v>8.6</c:v>
                </c:pt>
                <c:pt idx="40">
                  <c:v>3.4</c:v>
                </c:pt>
                <c:pt idx="41">
                  <c:v>69.6</c:v>
                </c:pt>
                <c:pt idx="42">
                  <c:v>5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098487672"/>
        <c:axId val="2074739624"/>
      </c:barChart>
      <c:catAx>
        <c:axId val="2098487672"/>
        <c:scaling>
          <c:orientation val="minMax"/>
        </c:scaling>
        <c:delete val="0"/>
        <c:axPos val="b"/>
        <c:majorTickMark val="out"/>
        <c:minorTickMark val="none"/>
        <c:tickLblPos val="nextTo"/>
        <c:crossAx val="2074739624"/>
        <c:crosses val="autoZero"/>
        <c:auto val="1"/>
        <c:lblAlgn val="ctr"/>
        <c:lblOffset val="100"/>
        <c:noMultiLvlLbl val="0"/>
      </c:catAx>
      <c:valAx>
        <c:axId val="20747396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848767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aseline="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0321741032371"/>
          <c:y val="0.0511636851845132"/>
          <c:w val="0.866095800524935"/>
          <c:h val="0.833390906781814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strRef>
              <c:f>Sheet1!$M$5:$O$5</c:f>
              <c:strCache>
                <c:ptCount val="3"/>
                <c:pt idx="0">
                  <c:v>Liver</c:v>
                </c:pt>
                <c:pt idx="1">
                  <c:v>Placenta</c:v>
                </c:pt>
                <c:pt idx="2">
                  <c:v>Heart</c:v>
                </c:pt>
              </c:strCache>
            </c:strRef>
          </c:cat>
          <c:val>
            <c:numRef>
              <c:f>Sheet1!$M$6:$O$6</c:f>
              <c:numCache>
                <c:formatCode>General</c:formatCode>
                <c:ptCount val="3"/>
                <c:pt idx="0">
                  <c:v>0.0</c:v>
                </c:pt>
                <c:pt idx="1">
                  <c:v>41.3793103448276</c:v>
                </c:pt>
                <c:pt idx="2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cat>
            <c:strRef>
              <c:f>Sheet1!$M$5:$O$5</c:f>
              <c:strCache>
                <c:ptCount val="3"/>
                <c:pt idx="0">
                  <c:v>Liver</c:v>
                </c:pt>
                <c:pt idx="1">
                  <c:v>Placenta</c:v>
                </c:pt>
                <c:pt idx="2">
                  <c:v>Heart</c:v>
                </c:pt>
              </c:strCache>
            </c:strRef>
          </c:cat>
          <c:val>
            <c:numRef>
              <c:f>Sheet1!$M$7:$O$7</c:f>
              <c:numCache>
                <c:formatCode>General</c:formatCode>
                <c:ptCount val="3"/>
                <c:pt idx="0">
                  <c:v>1.0</c:v>
                </c:pt>
                <c:pt idx="1">
                  <c:v>32.0</c:v>
                </c:pt>
                <c:pt idx="2">
                  <c:v>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098718504"/>
        <c:axId val="2074931304"/>
      </c:barChart>
      <c:catAx>
        <c:axId val="2098718504"/>
        <c:scaling>
          <c:orientation val="minMax"/>
        </c:scaling>
        <c:delete val="0"/>
        <c:axPos val="b"/>
        <c:majorTickMark val="out"/>
        <c:minorTickMark val="none"/>
        <c:tickLblPos val="nextTo"/>
        <c:crossAx val="2074931304"/>
        <c:crosses val="autoZero"/>
        <c:auto val="1"/>
        <c:lblAlgn val="ctr"/>
        <c:lblOffset val="100"/>
        <c:noMultiLvlLbl val="0"/>
      </c:catAx>
      <c:valAx>
        <c:axId val="2074931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987185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12249172896779"/>
          <c:y val="0.0879331568270123"/>
          <c:w val="0.884299080919643"/>
          <c:h val="0.76620568717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Sheet1!$Q$5:$S$5</c:f>
              <c:strCache>
                <c:ptCount val="3"/>
                <c:pt idx="0">
                  <c:v>Liver</c:v>
                </c:pt>
                <c:pt idx="1">
                  <c:v>Placenta</c:v>
                </c:pt>
                <c:pt idx="2">
                  <c:v>Heart</c:v>
                </c:pt>
              </c:strCache>
            </c:strRef>
          </c:cat>
          <c:val>
            <c:numRef>
              <c:f>Sheet1!$Q$6:$S$6</c:f>
              <c:numCache>
                <c:formatCode>General</c:formatCode>
                <c:ptCount val="3"/>
                <c:pt idx="0">
                  <c:v>0.0</c:v>
                </c:pt>
                <c:pt idx="1">
                  <c:v>32.25806451612903</c:v>
                </c:pt>
                <c:pt idx="2">
                  <c:v>0.0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cat>
            <c:strRef>
              <c:f>Sheet1!$Q$5:$S$5</c:f>
              <c:strCache>
                <c:ptCount val="3"/>
                <c:pt idx="0">
                  <c:v>Liver</c:v>
                </c:pt>
                <c:pt idx="1">
                  <c:v>Placenta</c:v>
                </c:pt>
                <c:pt idx="2">
                  <c:v>Heart</c:v>
                </c:pt>
              </c:strCache>
            </c:strRef>
          </c:cat>
          <c:val>
            <c:numRef>
              <c:f>Sheet1!$Q$7:$S$7</c:f>
              <c:numCache>
                <c:formatCode>General</c:formatCode>
                <c:ptCount val="3"/>
                <c:pt idx="0">
                  <c:v>7.0</c:v>
                </c:pt>
                <c:pt idx="1">
                  <c:v>44.9</c:v>
                </c:pt>
                <c:pt idx="2">
                  <c:v>6.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074373368"/>
        <c:axId val="2074808024"/>
      </c:barChart>
      <c:catAx>
        <c:axId val="2074373368"/>
        <c:scaling>
          <c:orientation val="minMax"/>
        </c:scaling>
        <c:delete val="0"/>
        <c:axPos val="b"/>
        <c:majorTickMark val="out"/>
        <c:minorTickMark val="none"/>
        <c:tickLblPos val="nextTo"/>
        <c:crossAx val="2074808024"/>
        <c:crosses val="autoZero"/>
        <c:auto val="1"/>
        <c:lblAlgn val="ctr"/>
        <c:lblOffset val="100"/>
        <c:noMultiLvlLbl val="0"/>
      </c:catAx>
      <c:valAx>
        <c:axId val="20748080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74373368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>
      <a:noFill/>
    </a:ln>
  </c:spPr>
  <c:txPr>
    <a:bodyPr/>
    <a:lstStyle/>
    <a:p>
      <a:pPr>
        <a:defRPr sz="800" baseline="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strRef>
              <c:f>Sheet1!$S$4:$AG$4</c:f>
              <c:strCache>
                <c:ptCount val="15"/>
                <c:pt idx="0">
                  <c:v>Liver </c:v>
                </c:pt>
                <c:pt idx="1">
                  <c:v>Placenta</c:v>
                </c:pt>
                <c:pt idx="2">
                  <c:v>Heart</c:v>
                </c:pt>
                <c:pt idx="4">
                  <c:v>Liver </c:v>
                </c:pt>
                <c:pt idx="5">
                  <c:v>Placenta</c:v>
                </c:pt>
                <c:pt idx="6">
                  <c:v>Heart</c:v>
                </c:pt>
                <c:pt idx="8">
                  <c:v>Liver </c:v>
                </c:pt>
                <c:pt idx="9">
                  <c:v>Placenta</c:v>
                </c:pt>
                <c:pt idx="10">
                  <c:v>Heart</c:v>
                </c:pt>
                <c:pt idx="12">
                  <c:v>Liver </c:v>
                </c:pt>
                <c:pt idx="13">
                  <c:v>Placenta</c:v>
                </c:pt>
                <c:pt idx="14">
                  <c:v>Heart</c:v>
                </c:pt>
              </c:strCache>
            </c:strRef>
          </c:cat>
          <c:val>
            <c:numRef>
              <c:f>Sheet1!$S$5:$AG$5</c:f>
              <c:numCache>
                <c:formatCode>General</c:formatCode>
                <c:ptCount val="15"/>
                <c:pt idx="0">
                  <c:v>15.625</c:v>
                </c:pt>
                <c:pt idx="1">
                  <c:v>93.10344827586205</c:v>
                </c:pt>
                <c:pt idx="2">
                  <c:v>10.71428571428571</c:v>
                </c:pt>
                <c:pt idx="4">
                  <c:v>3.125</c:v>
                </c:pt>
                <c:pt idx="5">
                  <c:v>93.10344827586205</c:v>
                </c:pt>
                <c:pt idx="6">
                  <c:v>3.571428571428571</c:v>
                </c:pt>
                <c:pt idx="8">
                  <c:v>9.375</c:v>
                </c:pt>
                <c:pt idx="9">
                  <c:v>96.55172413793096</c:v>
                </c:pt>
                <c:pt idx="10">
                  <c:v>0.0</c:v>
                </c:pt>
                <c:pt idx="12">
                  <c:v>3.125</c:v>
                </c:pt>
                <c:pt idx="13">
                  <c:v>68.9655172413794</c:v>
                </c:pt>
                <c:pt idx="14">
                  <c:v>7.142857142857141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2"/>
            <c:invertIfNegative val="0"/>
            <c:bubble3D val="0"/>
          </c:dPt>
          <c:dPt>
            <c:idx val="1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</c:spPr>
          </c:dPt>
          <c:dPt>
            <c:idx val="14"/>
            <c:invertIfNegative val="0"/>
            <c:bubble3D val="0"/>
          </c:dPt>
          <c:cat>
            <c:strRef>
              <c:f>Sheet1!$S$4:$AG$4</c:f>
              <c:strCache>
                <c:ptCount val="15"/>
                <c:pt idx="0">
                  <c:v>Liver </c:v>
                </c:pt>
                <c:pt idx="1">
                  <c:v>Placenta</c:v>
                </c:pt>
                <c:pt idx="2">
                  <c:v>Heart</c:v>
                </c:pt>
                <c:pt idx="4">
                  <c:v>Liver </c:v>
                </c:pt>
                <c:pt idx="5">
                  <c:v>Placenta</c:v>
                </c:pt>
                <c:pt idx="6">
                  <c:v>Heart</c:v>
                </c:pt>
                <c:pt idx="8">
                  <c:v>Liver </c:v>
                </c:pt>
                <c:pt idx="9">
                  <c:v>Placenta</c:v>
                </c:pt>
                <c:pt idx="10">
                  <c:v>Heart</c:v>
                </c:pt>
                <c:pt idx="12">
                  <c:v>Liver </c:v>
                </c:pt>
                <c:pt idx="13">
                  <c:v>Placenta</c:v>
                </c:pt>
                <c:pt idx="14">
                  <c:v>Heart</c:v>
                </c:pt>
              </c:strCache>
            </c:strRef>
          </c:cat>
          <c:val>
            <c:numRef>
              <c:f>Sheet1!$S$6:$AG$6</c:f>
              <c:numCache>
                <c:formatCode>General</c:formatCode>
                <c:ptCount val="15"/>
                <c:pt idx="0">
                  <c:v>18.77</c:v>
                </c:pt>
                <c:pt idx="1">
                  <c:v>80.0</c:v>
                </c:pt>
                <c:pt idx="2">
                  <c:v>11.77</c:v>
                </c:pt>
                <c:pt idx="4">
                  <c:v>16.16</c:v>
                </c:pt>
                <c:pt idx="5">
                  <c:v>70.0</c:v>
                </c:pt>
                <c:pt idx="6">
                  <c:v>15.85</c:v>
                </c:pt>
                <c:pt idx="8">
                  <c:v>11.38</c:v>
                </c:pt>
                <c:pt idx="9">
                  <c:v>60.0</c:v>
                </c:pt>
                <c:pt idx="10">
                  <c:v>6.02</c:v>
                </c:pt>
                <c:pt idx="12">
                  <c:v>5.649999999999998</c:v>
                </c:pt>
                <c:pt idx="13">
                  <c:v>84.0</c:v>
                </c:pt>
                <c:pt idx="14">
                  <c:v>1.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074220648"/>
        <c:axId val="2098749096"/>
      </c:barChart>
      <c:catAx>
        <c:axId val="2074220648"/>
        <c:scaling>
          <c:orientation val="minMax"/>
        </c:scaling>
        <c:delete val="0"/>
        <c:axPos val="b"/>
        <c:majorTickMark val="out"/>
        <c:minorTickMark val="none"/>
        <c:tickLblPos val="nextTo"/>
        <c:crossAx val="2098749096"/>
        <c:crosses val="autoZero"/>
        <c:auto val="1"/>
        <c:lblAlgn val="ctr"/>
        <c:lblOffset val="100"/>
        <c:noMultiLvlLbl val="0"/>
      </c:catAx>
      <c:valAx>
        <c:axId val="20987490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7422064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aseline="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1373550444702"/>
          <c:y val="0.142131175625407"/>
          <c:w val="0.833641451367796"/>
          <c:h val="0.415493933813876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8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2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2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cat>
            <c:strRef>
              <c:f>Sheet1!$D$32:$Z$32</c:f>
              <c:strCache>
                <c:ptCount val="23"/>
                <c:pt idx="0">
                  <c:v>Liver</c:v>
                </c:pt>
                <c:pt idx="1">
                  <c:v>Placenta</c:v>
                </c:pt>
                <c:pt idx="2">
                  <c:v>Heart</c:v>
                </c:pt>
                <c:pt idx="4">
                  <c:v>Liver</c:v>
                </c:pt>
                <c:pt idx="5">
                  <c:v>Placenta</c:v>
                </c:pt>
                <c:pt idx="6">
                  <c:v>Heart</c:v>
                </c:pt>
                <c:pt idx="8">
                  <c:v>Liver</c:v>
                </c:pt>
                <c:pt idx="9">
                  <c:v>Placenta</c:v>
                </c:pt>
                <c:pt idx="10">
                  <c:v>Heart</c:v>
                </c:pt>
                <c:pt idx="12">
                  <c:v>Liver</c:v>
                </c:pt>
                <c:pt idx="13">
                  <c:v>Placenta</c:v>
                </c:pt>
                <c:pt idx="14">
                  <c:v>Heart</c:v>
                </c:pt>
                <c:pt idx="16">
                  <c:v>Liver</c:v>
                </c:pt>
                <c:pt idx="17">
                  <c:v>Placenta</c:v>
                </c:pt>
                <c:pt idx="18">
                  <c:v>Heart</c:v>
                </c:pt>
                <c:pt idx="20">
                  <c:v>Liver</c:v>
                </c:pt>
                <c:pt idx="21">
                  <c:v>Placenta</c:v>
                </c:pt>
                <c:pt idx="22">
                  <c:v>Heart</c:v>
                </c:pt>
              </c:strCache>
            </c:strRef>
          </c:cat>
          <c:val>
            <c:numRef>
              <c:f>Sheet1!$D$33:$Z$33</c:f>
              <c:numCache>
                <c:formatCode>General</c:formatCode>
                <c:ptCount val="23"/>
                <c:pt idx="0">
                  <c:v>0.0</c:v>
                </c:pt>
                <c:pt idx="1">
                  <c:v>44.0</c:v>
                </c:pt>
                <c:pt idx="2">
                  <c:v>11.76470588235294</c:v>
                </c:pt>
                <c:pt idx="4">
                  <c:v>0.0</c:v>
                </c:pt>
                <c:pt idx="5">
                  <c:v>40.0</c:v>
                </c:pt>
                <c:pt idx="6">
                  <c:v>5.882352941176467</c:v>
                </c:pt>
                <c:pt idx="8">
                  <c:v>0.0</c:v>
                </c:pt>
                <c:pt idx="9">
                  <c:v>40.0</c:v>
                </c:pt>
                <c:pt idx="10">
                  <c:v>11.76470588235294</c:v>
                </c:pt>
                <c:pt idx="12">
                  <c:v>3.448275862068965</c:v>
                </c:pt>
                <c:pt idx="13">
                  <c:v>44.0</c:v>
                </c:pt>
                <c:pt idx="14">
                  <c:v>11.76470588235294</c:v>
                </c:pt>
                <c:pt idx="16">
                  <c:v>0.0</c:v>
                </c:pt>
                <c:pt idx="17">
                  <c:v>40.0</c:v>
                </c:pt>
                <c:pt idx="18">
                  <c:v>2.941176470588235</c:v>
                </c:pt>
                <c:pt idx="20">
                  <c:v>0.0</c:v>
                </c:pt>
                <c:pt idx="21">
                  <c:v>48.0</c:v>
                </c:pt>
                <c:pt idx="22">
                  <c:v>14.70588235294118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2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3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1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dPt>
          <c:dPt>
            <c:idx val="20"/>
            <c:invertIfNegative val="0"/>
            <c:bubble3D val="0"/>
          </c:dPt>
          <c:dPt>
            <c:idx val="21"/>
            <c:invertIfNegative val="0"/>
            <c:bubble3D val="0"/>
          </c:dPt>
          <c:dPt>
            <c:idx val="22"/>
            <c:invertIfNegative val="0"/>
            <c:bubble3D val="0"/>
          </c:dPt>
          <c:cat>
            <c:strRef>
              <c:f>Sheet1!$D$32:$Z$32</c:f>
              <c:strCache>
                <c:ptCount val="23"/>
                <c:pt idx="0">
                  <c:v>Liver</c:v>
                </c:pt>
                <c:pt idx="1">
                  <c:v>Placenta</c:v>
                </c:pt>
                <c:pt idx="2">
                  <c:v>Heart</c:v>
                </c:pt>
                <c:pt idx="4">
                  <c:v>Liver</c:v>
                </c:pt>
                <c:pt idx="5">
                  <c:v>Placenta</c:v>
                </c:pt>
                <c:pt idx="6">
                  <c:v>Heart</c:v>
                </c:pt>
                <c:pt idx="8">
                  <c:v>Liver</c:v>
                </c:pt>
                <c:pt idx="9">
                  <c:v>Placenta</c:v>
                </c:pt>
                <c:pt idx="10">
                  <c:v>Heart</c:v>
                </c:pt>
                <c:pt idx="12">
                  <c:v>Liver</c:v>
                </c:pt>
                <c:pt idx="13">
                  <c:v>Placenta</c:v>
                </c:pt>
                <c:pt idx="14">
                  <c:v>Heart</c:v>
                </c:pt>
                <c:pt idx="16">
                  <c:v>Liver</c:v>
                </c:pt>
                <c:pt idx="17">
                  <c:v>Placenta</c:v>
                </c:pt>
                <c:pt idx="18">
                  <c:v>Heart</c:v>
                </c:pt>
                <c:pt idx="20">
                  <c:v>Liver</c:v>
                </c:pt>
                <c:pt idx="21">
                  <c:v>Placenta</c:v>
                </c:pt>
                <c:pt idx="22">
                  <c:v>Heart</c:v>
                </c:pt>
              </c:strCache>
            </c:strRef>
          </c:cat>
          <c:val>
            <c:numRef>
              <c:f>Sheet1!$D$34:$Z$34</c:f>
              <c:numCache>
                <c:formatCode>General</c:formatCode>
                <c:ptCount val="23"/>
                <c:pt idx="0">
                  <c:v>1.46</c:v>
                </c:pt>
                <c:pt idx="1">
                  <c:v>49.01</c:v>
                </c:pt>
                <c:pt idx="2">
                  <c:v>7.619999999999996</c:v>
                </c:pt>
                <c:pt idx="4">
                  <c:v>11.31</c:v>
                </c:pt>
                <c:pt idx="5">
                  <c:v>45.0</c:v>
                </c:pt>
                <c:pt idx="6">
                  <c:v>13.11</c:v>
                </c:pt>
                <c:pt idx="8">
                  <c:v>6.89</c:v>
                </c:pt>
                <c:pt idx="9">
                  <c:v>42.91</c:v>
                </c:pt>
                <c:pt idx="10">
                  <c:v>12.7</c:v>
                </c:pt>
                <c:pt idx="12">
                  <c:v>5.28</c:v>
                </c:pt>
                <c:pt idx="13">
                  <c:v>40.53</c:v>
                </c:pt>
                <c:pt idx="14">
                  <c:v>11.86</c:v>
                </c:pt>
                <c:pt idx="16">
                  <c:v>3.74</c:v>
                </c:pt>
                <c:pt idx="17">
                  <c:v>22.34</c:v>
                </c:pt>
                <c:pt idx="18">
                  <c:v>4.37</c:v>
                </c:pt>
                <c:pt idx="20">
                  <c:v>27.0</c:v>
                </c:pt>
                <c:pt idx="21">
                  <c:v>37.75</c:v>
                </c:pt>
                <c:pt idx="22">
                  <c:v>26.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075041128"/>
        <c:axId val="2098398520"/>
      </c:barChart>
      <c:catAx>
        <c:axId val="2075041128"/>
        <c:scaling>
          <c:orientation val="minMax"/>
        </c:scaling>
        <c:delete val="0"/>
        <c:axPos val="b"/>
        <c:majorTickMark val="out"/>
        <c:minorTickMark val="none"/>
        <c:tickLblPos val="nextTo"/>
        <c:crossAx val="2098398520"/>
        <c:crosses val="autoZero"/>
        <c:auto val="1"/>
        <c:lblAlgn val="ctr"/>
        <c:lblOffset val="100"/>
        <c:noMultiLvlLbl val="0"/>
      </c:catAx>
      <c:valAx>
        <c:axId val="2098398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750411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 baseline="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4314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544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41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205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050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067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583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456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016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075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655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55F28-2585-8C42-9BF4-9F97D13692EB}" type="datetimeFigureOut">
              <a:rPr lang="en-US" smtClean="0"/>
              <a:t>7/24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8EAC93-BA03-F34C-AEEB-8B97A96BD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4400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chart" Target="../charts/chart4.xml"/><Relationship Id="rId12" Type="http://schemas.openxmlformats.org/officeDocument/2006/relationships/chart" Target="../charts/chart5.xml"/><Relationship Id="rId13" Type="http://schemas.openxmlformats.org/officeDocument/2006/relationships/image" Target="../media/image7.tiff"/><Relationship Id="rId14" Type="http://schemas.openxmlformats.org/officeDocument/2006/relationships/image" Target="../media/image8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chart" Target="../charts/chart1.xml"/><Relationship Id="rId9" Type="http://schemas.openxmlformats.org/officeDocument/2006/relationships/chart" Target="../charts/chart2.xml"/><Relationship Id="rId10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45_SB_CHST11.tif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325501" y="6825790"/>
            <a:ext cx="647199" cy="1902764"/>
          </a:xfrm>
          <a:prstGeom prst="rect">
            <a:avLst/>
          </a:prstGeom>
        </p:spPr>
      </p:pic>
      <p:pic>
        <p:nvPicPr>
          <p:cNvPr id="5" name="Picture 4" descr="45_TAB_CHST11.tiff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973283" y="6803738"/>
            <a:ext cx="659457" cy="1952059"/>
          </a:xfrm>
          <a:prstGeom prst="rect">
            <a:avLst/>
          </a:prstGeom>
        </p:spPr>
      </p:pic>
      <p:pic>
        <p:nvPicPr>
          <p:cNvPr id="6" name="Picture 5" descr="45_SB_CHRM3.tif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434239" y="6082658"/>
            <a:ext cx="484445" cy="1957487"/>
          </a:xfrm>
          <a:prstGeom prst="rect">
            <a:avLst/>
          </a:prstGeom>
        </p:spPr>
      </p:pic>
      <p:pic>
        <p:nvPicPr>
          <p:cNvPr id="7" name="Picture 6" descr="45_TAB_CHRM3.tiff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051985" y="6123660"/>
            <a:ext cx="454961" cy="1904967"/>
          </a:xfrm>
          <a:prstGeom prst="rect">
            <a:avLst/>
          </a:prstGeom>
        </p:spPr>
      </p:pic>
      <p:pic>
        <p:nvPicPr>
          <p:cNvPr id="8" name="Picture 7" descr="R012114_SB_ZBTB22.tiff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2265136" y="7683302"/>
            <a:ext cx="544945" cy="1679781"/>
          </a:xfrm>
          <a:prstGeom prst="rect">
            <a:avLst/>
          </a:prstGeom>
        </p:spPr>
      </p:pic>
      <p:pic>
        <p:nvPicPr>
          <p:cNvPr id="9" name="Picture 8" descr="R012114_TAB_ZBTB22.tiff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886882" y="7696012"/>
            <a:ext cx="539753" cy="1659553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198617" y="6690046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Array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243445" y="7452969"/>
            <a:ext cx="338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81%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43445" y="6918473"/>
            <a:ext cx="338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70%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43445" y="8492896"/>
            <a:ext cx="338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66%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629865" y="6690046"/>
            <a:ext cx="3672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SBS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881763" y="7446619"/>
            <a:ext cx="338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44%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881763" y="6932330"/>
            <a:ext cx="338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37%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881763" y="8503747"/>
            <a:ext cx="3386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dirty="0" smtClean="0">
                <a:latin typeface="Arial"/>
                <a:cs typeface="Arial"/>
              </a:rPr>
              <a:t>66%</a:t>
            </a:r>
            <a:endParaRPr lang="en-US" sz="600" dirty="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85947" y="6546536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H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680828" y="6546536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I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85947" y="7298876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J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85947" y="8111020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L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680828" y="7298876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K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680828" y="8111020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M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16285" y="3036558"/>
            <a:ext cx="26380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RGMA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350517" y="3036558"/>
            <a:ext cx="26380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>
                <a:latin typeface="Arial" pitchFamily="34" charset="0"/>
                <a:cs typeface="Arial" pitchFamily="34" charset="0"/>
              </a:rPr>
              <a:t>H</a:t>
            </a:r>
            <a:r>
              <a:rPr lang="en-US" sz="1100" i="1" dirty="0" smtClean="0">
                <a:latin typeface="Arial" pitchFamily="34" charset="0"/>
                <a:cs typeface="Arial" pitchFamily="34" charset="0"/>
              </a:rPr>
              <a:t>OXD2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641009" y="4198501"/>
            <a:ext cx="26380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SFRP1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490945" y="5242430"/>
            <a:ext cx="48289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PRRT1</a:t>
            </a:r>
          </a:p>
        </p:txBody>
      </p:sp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9203210"/>
              </p:ext>
            </p:extLst>
          </p:nvPr>
        </p:nvGraphicFramePr>
        <p:xfrm>
          <a:off x="1479825" y="5246235"/>
          <a:ext cx="4650090" cy="14307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8" name="Chart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37094108"/>
              </p:ext>
            </p:extLst>
          </p:nvPr>
        </p:nvGraphicFramePr>
        <p:xfrm>
          <a:off x="4127640" y="3395343"/>
          <a:ext cx="1504386" cy="7546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39" name="Chart 3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3832165"/>
              </p:ext>
            </p:extLst>
          </p:nvPr>
        </p:nvGraphicFramePr>
        <p:xfrm>
          <a:off x="4127640" y="4483633"/>
          <a:ext cx="1436305" cy="7153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40" name="TextBox 39"/>
          <p:cNvSpPr txBox="1"/>
          <p:nvPr/>
        </p:nvSpPr>
        <p:spPr>
          <a:xfrm rot="16200000">
            <a:off x="998914" y="3371041"/>
            <a:ext cx="8942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% Methylation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998915" y="4508556"/>
            <a:ext cx="8942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% Methylation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998915" y="5646071"/>
            <a:ext cx="8942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% Methylation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3615118" y="3371041"/>
            <a:ext cx="8942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% Methylation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3615119" y="4489375"/>
            <a:ext cx="8942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Arial" pitchFamily="34" charset="0"/>
                <a:cs typeface="Arial" pitchFamily="34" charset="0"/>
              </a:rPr>
              <a:t>% Methylation</a:t>
            </a:r>
            <a:endParaRPr 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360019" y="4106313"/>
            <a:ext cx="26380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RASSF1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6" name="Chart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2403636"/>
              </p:ext>
            </p:extLst>
          </p:nvPr>
        </p:nvGraphicFramePr>
        <p:xfrm>
          <a:off x="1479825" y="2980152"/>
          <a:ext cx="2174887" cy="11698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7" name="Chart 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8685897"/>
              </p:ext>
            </p:extLst>
          </p:nvPr>
        </p:nvGraphicFramePr>
        <p:xfrm>
          <a:off x="1490945" y="4095547"/>
          <a:ext cx="2540693" cy="11616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pic>
        <p:nvPicPr>
          <p:cNvPr id="84" name="Picture 83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344" y="283078"/>
            <a:ext cx="2670508" cy="2663322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668" y="283078"/>
            <a:ext cx="2668075" cy="2660904"/>
          </a:xfrm>
          <a:prstGeom prst="rect">
            <a:avLst/>
          </a:prstGeom>
        </p:spPr>
      </p:pic>
      <p:cxnSp>
        <p:nvCxnSpPr>
          <p:cNvPr id="87" name="Straight Connector 86"/>
          <p:cNvCxnSpPr/>
          <p:nvPr/>
        </p:nvCxnSpPr>
        <p:spPr>
          <a:xfrm>
            <a:off x="1601542" y="6755706"/>
            <a:ext cx="12696" cy="2003061"/>
          </a:xfrm>
          <a:prstGeom prst="line">
            <a:avLst/>
          </a:prstGeom>
          <a:ln w="31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4277288" y="6755706"/>
            <a:ext cx="12696" cy="2003061"/>
          </a:xfrm>
          <a:prstGeom prst="line">
            <a:avLst/>
          </a:prstGeom>
          <a:ln w="317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3836935" y="6690046"/>
            <a:ext cx="4283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Array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272284" y="6690046"/>
            <a:ext cx="3672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SBS</a:t>
            </a:r>
            <a:endParaRPr lang="en-US" sz="800" dirty="0">
              <a:latin typeface="Times New Roman"/>
              <a:cs typeface="Times New Roman"/>
            </a:endParaRPr>
          </a:p>
        </p:txBody>
      </p:sp>
      <p:cxnSp>
        <p:nvCxnSpPr>
          <p:cNvPr id="92" name="Straight Arrow Connector 91"/>
          <p:cNvCxnSpPr/>
          <p:nvPr/>
        </p:nvCxnSpPr>
        <p:spPr>
          <a:xfrm>
            <a:off x="1547674" y="7018865"/>
            <a:ext cx="215520" cy="1"/>
          </a:xfrm>
          <a:prstGeom prst="straightConnector1">
            <a:avLst/>
          </a:prstGeom>
          <a:ln w="19050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/>
          <p:nvPr/>
        </p:nvCxnSpPr>
        <p:spPr>
          <a:xfrm>
            <a:off x="1504950" y="7543800"/>
            <a:ext cx="215520" cy="1"/>
          </a:xfrm>
          <a:prstGeom prst="straightConnector1">
            <a:avLst/>
          </a:prstGeom>
          <a:ln w="19050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/>
          <p:nvPr/>
        </p:nvCxnSpPr>
        <p:spPr>
          <a:xfrm>
            <a:off x="1525152" y="8596840"/>
            <a:ext cx="215520" cy="1"/>
          </a:xfrm>
          <a:prstGeom prst="straightConnector1">
            <a:avLst/>
          </a:prstGeom>
          <a:ln w="19050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/>
          <p:nvPr/>
        </p:nvCxnSpPr>
        <p:spPr>
          <a:xfrm>
            <a:off x="4169965" y="7031492"/>
            <a:ext cx="215520" cy="1"/>
          </a:xfrm>
          <a:prstGeom prst="straightConnector1">
            <a:avLst/>
          </a:prstGeom>
          <a:ln w="19050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/>
          <p:nvPr/>
        </p:nvCxnSpPr>
        <p:spPr>
          <a:xfrm>
            <a:off x="4127241" y="7540552"/>
            <a:ext cx="215520" cy="1"/>
          </a:xfrm>
          <a:prstGeom prst="straightConnector1">
            <a:avLst/>
          </a:prstGeom>
          <a:ln w="19050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/>
          <p:nvPr/>
        </p:nvCxnSpPr>
        <p:spPr>
          <a:xfrm>
            <a:off x="4147443" y="8596767"/>
            <a:ext cx="215520" cy="1"/>
          </a:xfrm>
          <a:prstGeom prst="straightConnector1">
            <a:avLst/>
          </a:prstGeom>
          <a:ln w="19050">
            <a:solidFill>
              <a:schemeClr val="tx1"/>
            </a:solidFill>
            <a:tailEnd type="arrow" w="sm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428968" y="385896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3143283" y="385896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1064767" y="2980152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064767" y="4106313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E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3716285" y="2980152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D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3716285" y="4106313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F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1064767" y="5236819"/>
            <a:ext cx="457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itchFamily="34" charset="0"/>
                <a:cs typeface="Arial" pitchFamily="34" charset="0"/>
              </a:rPr>
              <a:t>G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1799515" y="6635618"/>
            <a:ext cx="1787013" cy="265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CHRM3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399747" y="6633270"/>
            <a:ext cx="1787013" cy="265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CHRM3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799515" y="7266330"/>
            <a:ext cx="1787013" cy="265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CHST11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399747" y="7271016"/>
            <a:ext cx="1787013" cy="265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CHST11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662347" y="8086960"/>
            <a:ext cx="1787013" cy="265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ZBTB22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276647" y="8084612"/>
            <a:ext cx="1787013" cy="265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i="1" dirty="0" smtClean="0">
                <a:latin typeface="Arial" pitchFamily="34" charset="0"/>
                <a:cs typeface="Arial" pitchFamily="34" charset="0"/>
              </a:rPr>
              <a:t>ZBTB22</a:t>
            </a:r>
            <a:endParaRPr lang="en-US" sz="1100" i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28893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50</Words>
  <Application>Microsoft Macintosh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Wisconsin School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id Alisch</dc:creator>
  <cp:lastModifiedBy>Reid Alisch</cp:lastModifiedBy>
  <cp:revision>8</cp:revision>
  <dcterms:created xsi:type="dcterms:W3CDTF">2013-07-24T16:41:16Z</dcterms:created>
  <dcterms:modified xsi:type="dcterms:W3CDTF">2013-07-24T21:08:00Z</dcterms:modified>
</cp:coreProperties>
</file>